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50"/>
  </p:normalViewPr>
  <p:slideViewPr>
    <p:cSldViewPr snapToGrid="0" snapToObjects="1">
      <p:cViewPr varScale="1">
        <p:scale>
          <a:sx n="105" d="100"/>
          <a:sy n="105" d="100"/>
        </p:scale>
        <p:origin x="13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4128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3403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2880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9489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360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6314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7784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1376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3641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4741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683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CD388-2D04-6348-BFF5-D24C96C09950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24E84-3F69-194D-B1D9-D51AC561CDA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082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0235988"/>
              </p:ext>
            </p:extLst>
          </p:nvPr>
        </p:nvGraphicFramePr>
        <p:xfrm>
          <a:off x="275558" y="1849126"/>
          <a:ext cx="8543924" cy="2999444"/>
        </p:xfrm>
        <a:graphic>
          <a:graphicData uri="http://schemas.openxmlformats.org/drawingml/2006/table">
            <a:tbl>
              <a:tblPr/>
              <a:tblGrid>
                <a:gridCol w="12362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1131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2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2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22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22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4756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70838"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0 nm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0 nm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0 nm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 nm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6036"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uching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% overlap</a:t>
                      </a:r>
                    </a:p>
                  </a:txBody>
                  <a:tcPr marL="10160" marR="10160" marT="1016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% overlap</a:t>
                      </a:r>
                    </a:p>
                  </a:txBody>
                  <a:tcPr marL="10160" marR="10160" marT="1016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7%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verlap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83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RG1a/SCN5A</a:t>
                      </a:r>
                    </a:p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n=41 </a:t>
                      </a:r>
                      <a:r>
                        <a:rPr lang="fr-F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s</a:t>
                      </a:r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c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by chanc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10 ± 0.87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6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61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0 ± 0,34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04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ce after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nferroni’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orrection: 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* 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125 ; ** P≤0.000122 ; *** P≤0.0000244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sured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68 ± 1,70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34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1.38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12 ± 1.28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3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82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P valu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1.57E-9 (***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4.71</a:t>
                      </a:r>
                      <a:r>
                        <a:rPr lang="fr-FR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E-9 (***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3.49E-10 (***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.51E-8 (***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0838">
                <a:tc>
                  <a:txBody>
                    <a:bodyPr/>
                    <a:lstStyle/>
                    <a:p>
                      <a:pPr algn="l" fontAlgn="b"/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083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RG1a/RyR2</a:t>
                      </a:r>
                    </a:p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n=26 </a:t>
                      </a:r>
                      <a:r>
                        <a:rPr lang="fr-F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s</a:t>
                      </a:r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c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by chanc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2 ± 0.66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3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54</a:t>
                      </a:r>
                      <a:endParaRPr lang="fi-FI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8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±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9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4 ± 0,23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ce after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nferroni’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orrection: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*  P≤0.00197 ; ** P≤0.000193 ; ***P≤0.000038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sured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2 ± 0.36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6 ± 0.30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9 ± 0.26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4 ± 0,24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P valu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0.16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0.16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14 (ns)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0838">
                <a:tc>
                  <a:txBody>
                    <a:bodyPr/>
                    <a:lstStyle/>
                    <a:p>
                      <a:pPr algn="l" fontAlgn="b"/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083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RG1a/GAPDH </a:t>
                      </a:r>
                    </a:p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n=13 </a:t>
                      </a:r>
                      <a:r>
                        <a:rPr lang="fr-F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s</a:t>
                      </a:r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c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by chanc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87 ± 2.65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7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1.3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,48 ± 1,23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4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1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ce with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nferroni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orrection: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*  P≤0.0039 ; ** P≤0.000386 ; ***P≤0.000077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sured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54 ± 1.68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6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1.1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,24 ±0,72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2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1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P valu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0.53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0.20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19 (ns)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0838"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083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N5A/GAPDH </a:t>
                      </a:r>
                    </a:p>
                    <a:p>
                      <a:pPr algn="ctr" fontAlgn="ctr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n=28 </a:t>
                      </a:r>
                      <a:r>
                        <a:rPr lang="fr-F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s</a:t>
                      </a:r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c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by chanc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31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± 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1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73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1.2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2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0.67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0.92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0.09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ce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fter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nferroni’s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orrection: </a:t>
                      </a:r>
                    </a:p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* P≤0.0013 ; ** P≤0.000186 ; ***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≤0.0000275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sured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92 ± 1.64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92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1.04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2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60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2</a:t>
                      </a:r>
                      <a:r>
                        <a:rPr lang="fr-FR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uk-U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±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0.28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083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P value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06 (*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2 (ns)</a:t>
                      </a:r>
                    </a:p>
                  </a:txBody>
                  <a:tcPr marL="10160" marR="10160" marT="1016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cxnSp>
        <p:nvCxnSpPr>
          <p:cNvPr id="6" name="Connecteur droit 5"/>
          <p:cNvCxnSpPr/>
          <p:nvPr/>
        </p:nvCxnSpPr>
        <p:spPr>
          <a:xfrm>
            <a:off x="275559" y="2228805"/>
            <a:ext cx="8603999" cy="1716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 flipH="1">
            <a:off x="1478248" y="2223532"/>
            <a:ext cx="0" cy="2735920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 flipH="1">
            <a:off x="2927782" y="1469875"/>
            <a:ext cx="0" cy="3491918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9"/>
          <p:cNvCxnSpPr/>
          <p:nvPr/>
        </p:nvCxnSpPr>
        <p:spPr>
          <a:xfrm flipH="1">
            <a:off x="3741127" y="1469875"/>
            <a:ext cx="0" cy="3491918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 flipH="1">
            <a:off x="4538262" y="1469875"/>
            <a:ext cx="0" cy="3491918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 flipH="1">
            <a:off x="5365260" y="1469875"/>
            <a:ext cx="0" cy="3491918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 flipH="1">
            <a:off x="6142056" y="1469875"/>
            <a:ext cx="0" cy="3491918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" name="Grouper 15"/>
          <p:cNvGrpSpPr/>
          <p:nvPr/>
        </p:nvGrpSpPr>
        <p:grpSpPr>
          <a:xfrm>
            <a:off x="3128893" y="1540995"/>
            <a:ext cx="468477" cy="218058"/>
            <a:chOff x="1270119" y="1698948"/>
            <a:chExt cx="684478" cy="326060"/>
          </a:xfrm>
        </p:grpSpPr>
        <p:sp>
          <p:nvSpPr>
            <p:cNvPr id="14" name="Ellipse 13"/>
            <p:cNvSpPr/>
            <p:nvPr/>
          </p:nvSpPr>
          <p:spPr>
            <a:xfrm>
              <a:off x="1270119" y="1698948"/>
              <a:ext cx="343277" cy="326060"/>
            </a:xfrm>
            <a:prstGeom prst="ellipse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Ellipse 14"/>
            <p:cNvSpPr/>
            <p:nvPr/>
          </p:nvSpPr>
          <p:spPr>
            <a:xfrm>
              <a:off x="1611320" y="1698948"/>
              <a:ext cx="343277" cy="326060"/>
            </a:xfrm>
            <a:prstGeom prst="ellipse">
              <a:avLst/>
            </a:prstGeom>
            <a:solidFill>
              <a:srgbClr val="FF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er 16"/>
          <p:cNvGrpSpPr/>
          <p:nvPr/>
        </p:nvGrpSpPr>
        <p:grpSpPr>
          <a:xfrm>
            <a:off x="3946961" y="1540995"/>
            <a:ext cx="418917" cy="218058"/>
            <a:chOff x="1270119" y="1698948"/>
            <a:chExt cx="612067" cy="326060"/>
          </a:xfrm>
        </p:grpSpPr>
        <p:sp>
          <p:nvSpPr>
            <p:cNvPr id="18" name="Ellipse 17"/>
            <p:cNvSpPr/>
            <p:nvPr/>
          </p:nvSpPr>
          <p:spPr>
            <a:xfrm>
              <a:off x="1270119" y="1698948"/>
              <a:ext cx="343277" cy="326060"/>
            </a:xfrm>
            <a:prstGeom prst="ellipse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Ellipse 18"/>
            <p:cNvSpPr/>
            <p:nvPr/>
          </p:nvSpPr>
          <p:spPr>
            <a:xfrm>
              <a:off x="1538909" y="1698948"/>
              <a:ext cx="343277" cy="326060"/>
            </a:xfrm>
            <a:prstGeom prst="ellipse">
              <a:avLst/>
            </a:prstGeom>
            <a:solidFill>
              <a:srgbClr val="FF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ouper 19"/>
          <p:cNvGrpSpPr/>
          <p:nvPr/>
        </p:nvGrpSpPr>
        <p:grpSpPr>
          <a:xfrm>
            <a:off x="4788754" y="1540995"/>
            <a:ext cx="356967" cy="218058"/>
            <a:chOff x="1270119" y="1698948"/>
            <a:chExt cx="521554" cy="326060"/>
          </a:xfrm>
        </p:grpSpPr>
        <p:sp>
          <p:nvSpPr>
            <p:cNvPr id="21" name="Ellipse 20"/>
            <p:cNvSpPr/>
            <p:nvPr/>
          </p:nvSpPr>
          <p:spPr>
            <a:xfrm>
              <a:off x="1270119" y="1698948"/>
              <a:ext cx="343277" cy="326060"/>
            </a:xfrm>
            <a:prstGeom prst="ellipse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Ellipse 21"/>
            <p:cNvSpPr/>
            <p:nvPr/>
          </p:nvSpPr>
          <p:spPr>
            <a:xfrm>
              <a:off x="1448396" y="1698948"/>
              <a:ext cx="343277" cy="326060"/>
            </a:xfrm>
            <a:prstGeom prst="ellipse">
              <a:avLst/>
            </a:prstGeom>
            <a:solidFill>
              <a:srgbClr val="FF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Grouper 22"/>
          <p:cNvGrpSpPr/>
          <p:nvPr/>
        </p:nvGrpSpPr>
        <p:grpSpPr>
          <a:xfrm>
            <a:off x="5615922" y="1540995"/>
            <a:ext cx="295017" cy="218058"/>
            <a:chOff x="1270119" y="1698948"/>
            <a:chExt cx="431041" cy="326060"/>
          </a:xfrm>
        </p:grpSpPr>
        <p:sp>
          <p:nvSpPr>
            <p:cNvPr id="24" name="Ellipse 23"/>
            <p:cNvSpPr/>
            <p:nvPr/>
          </p:nvSpPr>
          <p:spPr>
            <a:xfrm>
              <a:off x="1270119" y="1698948"/>
              <a:ext cx="343277" cy="326060"/>
            </a:xfrm>
            <a:prstGeom prst="ellipse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Ellipse 24"/>
            <p:cNvSpPr/>
            <p:nvPr/>
          </p:nvSpPr>
          <p:spPr>
            <a:xfrm>
              <a:off x="1357883" y="1698948"/>
              <a:ext cx="343277" cy="326060"/>
            </a:xfrm>
            <a:prstGeom prst="ellipse">
              <a:avLst/>
            </a:prstGeom>
            <a:solidFill>
              <a:srgbClr val="FF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6" name="Connecteur droit 25"/>
          <p:cNvCxnSpPr/>
          <p:nvPr/>
        </p:nvCxnSpPr>
        <p:spPr>
          <a:xfrm>
            <a:off x="275559" y="2889205"/>
            <a:ext cx="8603999" cy="1716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275559" y="3569925"/>
            <a:ext cx="8603999" cy="1716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>
            <a:off x="275559" y="4250645"/>
            <a:ext cx="8603999" cy="1716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/>
          <p:cNvCxnSpPr/>
          <p:nvPr/>
        </p:nvCxnSpPr>
        <p:spPr>
          <a:xfrm>
            <a:off x="277079" y="4950177"/>
            <a:ext cx="8603999" cy="1716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 flipH="1">
            <a:off x="277079" y="2219967"/>
            <a:ext cx="0" cy="2735916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/>
          <p:cNvCxnSpPr/>
          <p:nvPr/>
        </p:nvCxnSpPr>
        <p:spPr>
          <a:xfrm flipH="1">
            <a:off x="8876918" y="2233692"/>
            <a:ext cx="0" cy="2735916"/>
          </a:xfrm>
          <a:prstGeom prst="line">
            <a:avLst/>
          </a:prstGeom>
          <a:ln>
            <a:solidFill>
              <a:srgbClr val="7F7F7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/>
          <p:cNvCxnSpPr/>
          <p:nvPr/>
        </p:nvCxnSpPr>
        <p:spPr>
          <a:xfrm>
            <a:off x="2938108" y="1469873"/>
            <a:ext cx="320394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632785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</TotalTime>
  <Words>323</Words>
  <Application>Microsoft Macintosh PowerPoint</Application>
  <PresentationFormat>Affichage à l'écran (4:3)</PresentationFormat>
  <Paragraphs>8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THERINE ALEXANDRA EICHEL</dc:creator>
  <cp:lastModifiedBy>CATHERINE ALEXANDRA EICHEL</cp:lastModifiedBy>
  <cp:revision>5</cp:revision>
  <dcterms:created xsi:type="dcterms:W3CDTF">2019-02-26T19:30:58Z</dcterms:created>
  <dcterms:modified xsi:type="dcterms:W3CDTF">2019-10-28T19:09:42Z</dcterms:modified>
</cp:coreProperties>
</file>